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1" r:id="rId2"/>
    <p:sldId id="264" r:id="rId3"/>
    <p:sldId id="263" r:id="rId4"/>
  </p:sldIdLst>
  <p:sldSz cx="6858000" cy="9906000" type="A4"/>
  <p:notesSz cx="7010400" cy="9296400"/>
  <p:defaultTextStyle>
    <a:defPPr>
      <a:defRPr lang="zh-CN"/>
    </a:defPPr>
    <a:lvl1pPr marL="0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1pPr>
    <a:lvl2pPr marL="432511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2pPr>
    <a:lvl3pPr marL="865022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3pPr>
    <a:lvl4pPr marL="1297534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4pPr>
    <a:lvl5pPr marL="1730045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5pPr>
    <a:lvl6pPr marL="2162556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6pPr>
    <a:lvl7pPr marL="2595067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7pPr>
    <a:lvl8pPr marL="3027578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8pPr>
    <a:lvl9pPr marL="3460090" algn="l" defTabSz="865022" rtl="0" eaLnBrk="1" latinLnBrk="0" hangingPunct="1">
      <a:defRPr sz="170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c" initials="p" lastIdx="3" clrIdx="0">
    <p:extLst>
      <p:ext uri="{19B8F6BF-5375-455C-9EA6-DF929625EA0E}">
        <p15:presenceInfo xmlns:p15="http://schemas.microsoft.com/office/powerpoint/2012/main" userId="pc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348"/>
    <p:restoredTop sz="96229" autoAdjust="0"/>
  </p:normalViewPr>
  <p:slideViewPr>
    <p:cSldViewPr snapToGrid="0">
      <p:cViewPr varScale="1">
        <p:scale>
          <a:sx n="91" d="100"/>
          <a:sy n="91" d="100"/>
        </p:scale>
        <p:origin x="24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17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C29972-2C89-4E09-AC32-BEF22A289BCD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DAC28F-3045-4E50-8B63-C839737FDA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9808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7954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485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526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6724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9826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2994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469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4872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999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2327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6569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C997B-FCE4-4133-9199-E4515942252F}" type="datetimeFigureOut">
              <a:rPr lang="zh-CN" altLang="en-US" smtClean="0"/>
              <a:t>2024/9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E242D4-A8CA-42C3-833F-F2E8D06024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16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00291" y="194128"/>
            <a:ext cx="645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zh-CN" sz="1800" dirty="0">
                <a:highlight>
                  <a:srgbClr val="FFFF00"/>
                </a:highlight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zh-CN" sz="1800" dirty="0">
                <a:effectLst/>
                <a:highlight>
                  <a:srgbClr val="FFFF00"/>
                </a:highlight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hematic diagram of </a:t>
            </a:r>
            <a:r>
              <a:rPr lang="en-US" altLang="zh-CN" sz="1800" i="1" dirty="0">
                <a:effectLst/>
                <a:highlight>
                  <a:srgbClr val="FFFF00"/>
                </a:highlight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. biloba</a:t>
            </a:r>
            <a:r>
              <a:rPr lang="en-US" altLang="zh-CN" sz="1800" dirty="0">
                <a:effectLst/>
                <a:highlight>
                  <a:srgbClr val="FFFF00"/>
                </a:highlight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seedlings under drought and re-watering treatments.</a:t>
            </a:r>
            <a:r>
              <a:rPr lang="zh-CN" altLang="en-US" sz="18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zh-CN" sz="18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7E8EEEC-0EB6-5D43-BFC6-975BEFA482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" y="1800250"/>
            <a:ext cx="6858000" cy="22821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6763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00291" y="194128"/>
            <a:ext cx="645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eatmap of all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1 samples</a:t>
            </a:r>
            <a:r>
              <a:rPr lang="zh-CN" altLang="zh-CN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ased on the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ample correlation analysis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613EDD8-0B49-CF4B-8A71-95EC98397B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3" t="26244" r="22034" b="26063"/>
          <a:stretch/>
        </p:blipFill>
        <p:spPr>
          <a:xfrm>
            <a:off x="150156" y="1280943"/>
            <a:ext cx="6507550" cy="5431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8464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60FBD67-1A71-5542-8CE5-5ACF1599C2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116" y="1334184"/>
            <a:ext cx="3543300" cy="26797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4F041AC-E243-8D45-9487-754FD91E1F1C}"/>
              </a:ext>
            </a:extLst>
          </p:cNvPr>
          <p:cNvSpPr txBox="1"/>
          <p:nvPr/>
        </p:nvSpPr>
        <p:spPr>
          <a:xfrm>
            <a:off x="200291" y="194128"/>
            <a:ext cx="645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xpression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attern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nalysis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of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he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EG</a:t>
            </a:r>
            <a:r>
              <a:rPr lang="zh-CN" altLang="en-US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evm.TU.chr8.2086</a:t>
            </a:r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0900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441</TotalTime>
  <Words>47</Words>
  <Application>Microsoft Macintosh PowerPoint</Application>
  <PresentationFormat>A4 纸张(210x297 毫米)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c</dc:creator>
  <cp:lastModifiedBy>Microsoft Office User</cp:lastModifiedBy>
  <cp:revision>169</cp:revision>
  <cp:lastPrinted>2019-07-10T13:41:13Z</cp:lastPrinted>
  <dcterms:created xsi:type="dcterms:W3CDTF">2019-07-09T05:16:05Z</dcterms:created>
  <dcterms:modified xsi:type="dcterms:W3CDTF">2024-09-20T14:48:42Z</dcterms:modified>
</cp:coreProperties>
</file>